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F33293-1844-2547-A213-6EF179C5E7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CC21995-B882-BAD4-F39C-98D2B96180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2E2AC3-CE81-F50B-6FD9-122724E68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CBB478-FC2C-87B2-CF68-675FC3E49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262740-31A9-4019-6E33-6E9CB7686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032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384FBB9-F0FA-98BD-EEE5-1B0EE7548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624705F-C005-F8E1-BAE0-6A8792900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C2245D-FBBD-5A03-55D8-536ABCBC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4372C31-7BE1-46FD-C2BE-A3216403F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CD1AEA0-BEBF-B0CC-17DD-EF678AF4A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1208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25401BD-27BA-B66B-83BE-740AD8AB9E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83415C8-541E-A2E4-E4C4-D857887CFC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797828-74A9-0EB3-2443-DC79A52CF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770B893-69A9-FB19-EE1F-99DD6CEE4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B748DB7-D9A8-AC5B-A6AF-BD492E30B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32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F98E04-73DD-FFC9-A523-5434FD17F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9C1A1E8-22EF-0A9D-7B05-0A0B8E16BC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3F326C-7E36-E006-86F8-75C61BE39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22D74C0-8836-444E-B3DC-409B3D8F6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6C49F3-D218-F7C8-9527-E98A0C366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586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E5520C-D303-9563-97C5-66F9D406A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4D2A47A-C979-8E0F-DC7B-9D8BF69F67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2743C62-5BF1-6311-8828-F871E7A4E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04188AA-3FCD-BD86-03D0-429106BD1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7780A3-C0C2-B431-F8E9-51669CDDC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3309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4E08B47-7EBD-C73F-EF6D-31D20B62D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852300-10D9-5E9D-5C7F-6262DB755A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0992D94-F884-743B-FCF6-489CE48742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DB26FF1-9D05-E87D-5C04-671881A66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0D73A97-B424-D512-B6A9-CD582CB25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4EBCB19-2673-564A-FB05-507E4ABC7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664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32B84C-1537-694A-E920-DBC0217C6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A769241-F89E-D5BF-6920-1C8133901D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BFB27EE-FA60-E553-A462-F63253402E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82060B2-142E-41D4-723D-05B276A31C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A2CBC0F-747D-037B-FDD0-3E13007DFD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89A9F95-88D5-93A4-BC06-7DE20CFBD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FF9DFD7-D2F7-8D98-A6F4-07ACCEAA6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856A9F3-62B4-3105-2787-21091688B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835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EE5E0A-34A5-47B4-A4E6-C7C288AAF0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3576024-0EA9-2EFF-7266-CD83A9CA3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00A7E2D-F81C-AACC-6747-4F3E668CD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729F8A6-F82A-0CD1-9FE1-4C101D3B1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6548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B011349-AAFA-AC24-F194-5EEC33208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1E9F21B-F05E-7457-ED91-1939E2198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750CA47-D812-9770-8810-96196B382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4028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C0C9C7-791B-64C8-0537-0D43B98E93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2C3458E-36D9-0856-6A19-F9C83D2440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5F4E460-6997-FE89-9B6C-051EE94776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9107CCC-1C42-B9DC-EBED-67CE64E5A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B6D4A8F-6748-2E5E-5E82-F7EC315C4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B6CE596-55D0-838B-1FD7-EC136C2FB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9907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5CB1741-79F5-2BCE-0F74-2F73E27EA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18DFC719-411C-B2F4-B428-0E58D68B40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AE9E40-20DD-EC56-2014-038CD2E5E4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3F49B57-42C1-3EE8-6E99-EEF2ABEC0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8CFF03-D340-1BF0-9682-0DDCFA3A0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2CB2402-8B42-BC55-8847-0BBFA6590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0757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3C9E02B-CD9D-56CD-C500-8EDB84AB7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110F557-8C93-CE06-ED71-DF11B09BDD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62AEBC7-01A7-F38B-12A6-DB51458724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7F83EF-EAA9-47B5-8330-72FC7B10B2D6}" type="datetimeFigureOut">
              <a:rPr lang="fr-FR" smtClean="0"/>
              <a:t>14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A0FAD9-D006-410B-2EC4-A0564E60D8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52F7659-7E9A-AAE7-332B-AD4000B74E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3F1698-BE69-44D6-8E8C-4238996E37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080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BA3B7544-911A-C2B5-8AED-E0F3592FCB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5476" y="1771048"/>
            <a:ext cx="4537671" cy="4426181"/>
          </a:xfrm>
          <a:prstGeom prst="rect">
            <a:avLst/>
          </a:prstGeom>
        </p:spPr>
      </p:pic>
      <p:sp>
        <p:nvSpPr>
          <p:cNvPr id="8" name="Rectangle 1">
            <a:extLst>
              <a:ext uri="{FF2B5EF4-FFF2-40B4-BE49-F238E27FC236}">
                <a16:creationId xmlns:a16="http://schemas.microsoft.com/office/drawing/2014/main" id="{FE87D0F9-55EA-CEE4-8A1A-70B8C80DFC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0075" y="33686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14297B0E-54B9-55A1-E888-09B4A7F84847}"/>
              </a:ext>
            </a:extLst>
          </p:cNvPr>
          <p:cNvSpPr txBox="1"/>
          <p:nvPr/>
        </p:nvSpPr>
        <p:spPr>
          <a:xfrm>
            <a:off x="9466162" y="4117281"/>
            <a:ext cx="609760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4-METHYL-2-OXO-PENTANOIC ACID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2-HYDROXYPHENYLACETIC ACID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Cortisone </a:t>
            </a:r>
          </a:p>
          <a:p>
            <a:pPr algn="l" fontAlgn="t"/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lpha-aminobutyric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algn="l" fontAlgn="t"/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Vanillylmandelic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endParaRPr lang="fr-FR" sz="1200" dirty="0">
              <a:solidFill>
                <a:srgbClr val="333333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72E312F2-9344-54C0-250F-D6185D6612A4}"/>
              </a:ext>
            </a:extLst>
          </p:cNvPr>
          <p:cNvCxnSpPr/>
          <p:nvPr/>
        </p:nvCxnSpPr>
        <p:spPr>
          <a:xfrm>
            <a:off x="7546207" y="4379495"/>
            <a:ext cx="191995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id="{DD6E0B1E-BFCF-55B9-762E-FC3B8CA9E13D}"/>
              </a:ext>
            </a:extLst>
          </p:cNvPr>
          <p:cNvSpPr txBox="1"/>
          <p:nvPr/>
        </p:nvSpPr>
        <p:spPr>
          <a:xfrm>
            <a:off x="9466162" y="5210753"/>
            <a:ext cx="751251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t"/>
            <a:br>
              <a:rPr lang="fr-FR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</a:b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LYSINE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PHENYLALANINE</a:t>
            </a:r>
          </a:p>
        </p:txBody>
      </p:sp>
      <p:cxnSp>
        <p:nvCxnSpPr>
          <p:cNvPr id="17" name="Connecteur droit avec flèche 16">
            <a:extLst>
              <a:ext uri="{FF2B5EF4-FFF2-40B4-BE49-F238E27FC236}">
                <a16:creationId xmlns:a16="http://schemas.microsoft.com/office/drawing/2014/main" id="{98AB0230-BE6E-9B3C-A6C9-4578F2AACB44}"/>
              </a:ext>
            </a:extLst>
          </p:cNvPr>
          <p:cNvCxnSpPr/>
          <p:nvPr/>
        </p:nvCxnSpPr>
        <p:spPr>
          <a:xfrm>
            <a:off x="8643487" y="5775158"/>
            <a:ext cx="82267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09EEBFB0-7F73-1D01-673C-E9C26917D31A}"/>
              </a:ext>
            </a:extLst>
          </p:cNvPr>
          <p:cNvSpPr txBox="1"/>
          <p:nvPr/>
        </p:nvSpPr>
        <p:spPr>
          <a:xfrm>
            <a:off x="98625" y="0"/>
            <a:ext cx="2444851" cy="72943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Indole-3-carboxylic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C(O-16_1__2_0)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Hippur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onit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5-Hydroxyindoleacetic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Fumar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TYROS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Indole-3-Lactic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3-Methoxy-4-hydroxyhippuric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PIPECOLIC ACID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EUC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4-HYDROXYPHENYLACETAT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ARGIN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2-Hydroxy-4-methylpentanoic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3-Hydroxyglutarat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PROL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ASPARAG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URAT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N-ACETYL-L-PHENYLALAN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lpha-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ketoisovaler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3-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Hydroxyoctano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Kynurenine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ACTATE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Mal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GLUTAMIC ACID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Hydroxykynurenine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5-Hydroxy-L-tryptophan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MESOXALATE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etyl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-DL-carnitine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Isocitr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Quinolin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EPINEPHRINE </a:t>
            </a:r>
          </a:p>
          <a:p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3-METHYL-2-OXOVALERIC ACID </a:t>
            </a:r>
          </a:p>
          <a:p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henyllactic</a:t>
            </a:r>
            <a:r>
              <a:rPr lang="fr-FR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endParaRPr lang="fr-FR" sz="1200" dirty="0"/>
          </a:p>
          <a:p>
            <a:endParaRPr lang="fr-FR" sz="1200" b="0" i="0" dirty="0">
              <a:solidFill>
                <a:srgbClr val="333333"/>
              </a:solidFill>
              <a:effectLst/>
              <a:latin typeface="Arial" panose="020B0604020202020204" pitchFamily="34" charset="0"/>
            </a:endParaRPr>
          </a:p>
          <a:p>
            <a:endParaRPr lang="fr-FR" sz="1200" dirty="0"/>
          </a:p>
        </p:txBody>
      </p:sp>
      <p:cxnSp>
        <p:nvCxnSpPr>
          <p:cNvPr id="22" name="Connecteur droit avec flèche 21">
            <a:extLst>
              <a:ext uri="{FF2B5EF4-FFF2-40B4-BE49-F238E27FC236}">
                <a16:creationId xmlns:a16="http://schemas.microsoft.com/office/drawing/2014/main" id="{C931EBAE-111B-39CC-B024-62A897FE5BFE}"/>
              </a:ext>
            </a:extLst>
          </p:cNvPr>
          <p:cNvCxnSpPr>
            <a:cxnSpLocks/>
          </p:cNvCxnSpPr>
          <p:nvPr/>
        </p:nvCxnSpPr>
        <p:spPr>
          <a:xfrm flipH="1">
            <a:off x="1828800" y="4456497"/>
            <a:ext cx="406186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 2">
            <a:extLst>
              <a:ext uri="{FF2B5EF4-FFF2-40B4-BE49-F238E27FC236}">
                <a16:creationId xmlns:a16="http://schemas.microsoft.com/office/drawing/2014/main" id="{84FDF085-63CE-4973-5491-D5A209BE18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1168" y="207535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705F4BCD-074B-B5B5-F162-0A4751DA6228}"/>
              </a:ext>
            </a:extLst>
          </p:cNvPr>
          <p:cNvSpPr txBox="1"/>
          <p:nvPr/>
        </p:nvSpPr>
        <p:spPr>
          <a:xfrm>
            <a:off x="9466162" y="2024513"/>
            <a:ext cx="84894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UMICHROME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TAURINE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3-(4-HYDROXYPHENYL)LACTATE</a:t>
            </a:r>
          </a:p>
        </p:txBody>
      </p: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68C325EE-9589-C069-23EB-F2259F468AA3}"/>
              </a:ext>
            </a:extLst>
          </p:cNvPr>
          <p:cNvCxnSpPr/>
          <p:nvPr/>
        </p:nvCxnSpPr>
        <p:spPr>
          <a:xfrm>
            <a:off x="8591030" y="2481713"/>
            <a:ext cx="82267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ZoneTexte 34">
            <a:extLst>
              <a:ext uri="{FF2B5EF4-FFF2-40B4-BE49-F238E27FC236}">
                <a16:creationId xmlns:a16="http://schemas.microsoft.com/office/drawing/2014/main" id="{E6E79A5D-821B-1273-B20A-1BFFF9D6C074}"/>
              </a:ext>
            </a:extLst>
          </p:cNvPr>
          <p:cNvSpPr txBox="1"/>
          <p:nvPr/>
        </p:nvSpPr>
        <p:spPr>
          <a:xfrm>
            <a:off x="2918577" y="50023"/>
            <a:ext cx="3347469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lycoursodeoxycholic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LPHA-HYDROXYISOBUTYRIC ACID </a:t>
            </a:r>
          </a:p>
          <a:p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Indoxyl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sulfat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UANIDINOACETAT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2-Ethyl-2-hydroxybutyric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ALANIN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5-Oxoprolin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3-Hydroxyhexadecanoylcarnitin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THREONINE </a:t>
            </a:r>
          </a:p>
          <a:p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Succinic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Hydroxybutyrylcarnitine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XANTHINE </a:t>
            </a:r>
          </a:p>
          <a:p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Octenoyl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-L-carnitine </a:t>
            </a:r>
          </a:p>
          <a:p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CITRATE</a:t>
            </a:r>
            <a:endParaRPr lang="fr-FR" sz="1200" dirty="0"/>
          </a:p>
        </p:txBody>
      </p: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470C8A2C-7D46-10C3-8A4B-80A93797AD5F}"/>
              </a:ext>
            </a:extLst>
          </p:cNvPr>
          <p:cNvCxnSpPr>
            <a:cxnSpLocks/>
          </p:cNvCxnSpPr>
          <p:nvPr/>
        </p:nvCxnSpPr>
        <p:spPr>
          <a:xfrm flipH="1" flipV="1">
            <a:off x="3734602" y="2670844"/>
            <a:ext cx="2233061" cy="98675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ZoneTexte 40">
            <a:extLst>
              <a:ext uri="{FF2B5EF4-FFF2-40B4-BE49-F238E27FC236}">
                <a16:creationId xmlns:a16="http://schemas.microsoft.com/office/drawing/2014/main" id="{AC372C48-B327-4767-80DE-AC6C1F8982DE}"/>
              </a:ext>
            </a:extLst>
          </p:cNvPr>
          <p:cNvSpPr txBox="1"/>
          <p:nvPr/>
        </p:nvSpPr>
        <p:spPr>
          <a:xfrm>
            <a:off x="2841859" y="4797265"/>
            <a:ext cx="240390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LYOXYLIC ACID </a:t>
            </a:r>
          </a:p>
          <a:p>
            <a:pPr algn="l" fontAlgn="t"/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etoacetic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cid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C(31_0) </a:t>
            </a:r>
          </a:p>
          <a:p>
            <a:pPr algn="l" fontAlgn="t"/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Oleoylcarnitine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algn="l" fontAlgn="t"/>
            <a:r>
              <a:rPr lang="fr-FR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inoleyl</a:t>
            </a:r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carnitine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AICAR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L-CYSTINE </a:t>
            </a:r>
          </a:p>
          <a:p>
            <a:pPr algn="l" fontAlgn="t"/>
            <a:r>
              <a:rPr lang="fr-FR" sz="120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N-ACETYL-L-LEUCINE</a:t>
            </a:r>
          </a:p>
        </p:txBody>
      </p:sp>
      <p:cxnSp>
        <p:nvCxnSpPr>
          <p:cNvPr id="42" name="Connecteur droit avec flèche 41">
            <a:extLst>
              <a:ext uri="{FF2B5EF4-FFF2-40B4-BE49-F238E27FC236}">
                <a16:creationId xmlns:a16="http://schemas.microsoft.com/office/drawing/2014/main" id="{40A6FC68-C27C-C7A6-03BC-A17629D20EB0}"/>
              </a:ext>
            </a:extLst>
          </p:cNvPr>
          <p:cNvCxnSpPr>
            <a:cxnSpLocks/>
          </p:cNvCxnSpPr>
          <p:nvPr/>
        </p:nvCxnSpPr>
        <p:spPr>
          <a:xfrm flipH="1">
            <a:off x="4093395" y="5316631"/>
            <a:ext cx="10351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072AB01D-9FE5-A915-C520-85C6060B6F7A}"/>
              </a:ext>
            </a:extLst>
          </p:cNvPr>
          <p:cNvSpPr txBox="1"/>
          <p:nvPr/>
        </p:nvSpPr>
        <p:spPr>
          <a:xfrm>
            <a:off x="6266046" y="284753"/>
            <a:ext cx="5291579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 S2. Venn diagram showing common metabolites between different models (To explain Phe = PLS Phe, To explain Tyr = PLS Tyr, To explain PKU = OPLSDA).</a:t>
            </a:r>
            <a:endParaRPr lang="fr-FR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58567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3</Words>
  <Application>Microsoft Office PowerPoint</Application>
  <PresentationFormat>Grand écran</PresentationFormat>
  <Paragraphs>6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n Dos Santos</dc:creator>
  <cp:lastModifiedBy>Yann Dos Santos</cp:lastModifiedBy>
  <cp:revision>5</cp:revision>
  <dcterms:created xsi:type="dcterms:W3CDTF">2025-02-06T15:31:44Z</dcterms:created>
  <dcterms:modified xsi:type="dcterms:W3CDTF">2025-03-14T12:10:58Z</dcterms:modified>
</cp:coreProperties>
</file>